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3" r:id="rId2"/>
    <p:sldId id="272" r:id="rId3"/>
    <p:sldId id="264" r:id="rId4"/>
    <p:sldId id="277" r:id="rId5"/>
    <p:sldId id="278" r:id="rId6"/>
    <p:sldId id="270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856" autoAdjust="0"/>
    <p:restoredTop sz="94660"/>
  </p:normalViewPr>
  <p:slideViewPr>
    <p:cSldViewPr snapToGrid="0">
      <p:cViewPr>
        <p:scale>
          <a:sx n="66" d="100"/>
          <a:sy n="66" d="100"/>
        </p:scale>
        <p:origin x="1878" y="9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A3063-A4BD-453A-AA09-058AE7857567}" type="datetimeFigureOut">
              <a:rPr lang="zh-CN" altLang="en-US" smtClean="0"/>
              <a:pPr/>
              <a:t>2017/4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6A07E-1D41-44AB-A049-F696ECDAFCB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41479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A3063-A4BD-453A-AA09-058AE7857567}" type="datetimeFigureOut">
              <a:rPr lang="zh-CN" altLang="en-US" smtClean="0"/>
              <a:pPr/>
              <a:t>2017/4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6A07E-1D41-44AB-A049-F696ECDAFCB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70901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A3063-A4BD-453A-AA09-058AE7857567}" type="datetimeFigureOut">
              <a:rPr lang="zh-CN" altLang="en-US" smtClean="0"/>
              <a:pPr/>
              <a:t>2017/4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6A07E-1D41-44AB-A049-F696ECDAFCB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2529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A3063-A4BD-453A-AA09-058AE7857567}" type="datetimeFigureOut">
              <a:rPr lang="zh-CN" altLang="en-US" smtClean="0"/>
              <a:pPr/>
              <a:t>2017/4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6A07E-1D41-44AB-A049-F696ECDAFCB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8989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A3063-A4BD-453A-AA09-058AE7857567}" type="datetimeFigureOut">
              <a:rPr lang="zh-CN" altLang="en-US" smtClean="0"/>
              <a:pPr/>
              <a:t>2017/4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6A07E-1D41-44AB-A049-F696ECDAFCB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9995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A3063-A4BD-453A-AA09-058AE7857567}" type="datetimeFigureOut">
              <a:rPr lang="zh-CN" altLang="en-US" smtClean="0"/>
              <a:pPr/>
              <a:t>2017/4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6A07E-1D41-44AB-A049-F696ECDAFCB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6477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A3063-A4BD-453A-AA09-058AE7857567}" type="datetimeFigureOut">
              <a:rPr lang="zh-CN" altLang="en-US" smtClean="0"/>
              <a:pPr/>
              <a:t>2017/4/2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6A07E-1D41-44AB-A049-F696ECDAFCB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13508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A3063-A4BD-453A-AA09-058AE7857567}" type="datetimeFigureOut">
              <a:rPr lang="zh-CN" altLang="en-US" smtClean="0"/>
              <a:pPr/>
              <a:t>2017/4/2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6A07E-1D41-44AB-A049-F696ECDAFCB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87699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A3063-A4BD-453A-AA09-058AE7857567}" type="datetimeFigureOut">
              <a:rPr lang="zh-CN" altLang="en-US" smtClean="0"/>
              <a:pPr/>
              <a:t>2017/4/2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6A07E-1D41-44AB-A049-F696ECDAFCB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9043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A3063-A4BD-453A-AA09-058AE7857567}" type="datetimeFigureOut">
              <a:rPr lang="zh-CN" altLang="en-US" smtClean="0"/>
              <a:pPr/>
              <a:t>2017/4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6A07E-1D41-44AB-A049-F696ECDAFCB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1470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A3063-A4BD-453A-AA09-058AE7857567}" type="datetimeFigureOut">
              <a:rPr lang="zh-CN" altLang="en-US" smtClean="0"/>
              <a:pPr/>
              <a:t>2017/4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6A07E-1D41-44AB-A049-F696ECDAFCB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33126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7A3063-A4BD-453A-AA09-058AE7857567}" type="datetimeFigureOut">
              <a:rPr lang="zh-CN" altLang="en-US" smtClean="0"/>
              <a:pPr/>
              <a:t>2017/4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C6A07E-1D41-44AB-A049-F696ECDAFCB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92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/>
          <p:cNvSpPr/>
          <p:nvPr/>
        </p:nvSpPr>
        <p:spPr>
          <a:xfrm>
            <a:off x="5634079" y="1997838"/>
            <a:ext cx="3431181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the embryo edited using gRNA-2 and HF2-BE2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amplicons of the target region from the embryos were cloned into the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EM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 vector for Sanger sequencing. The number of clones for each pattern is indicated. gRNA-2 target sequence is underlined. PAM, green. Point mutation, red. </a:t>
            </a: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7082" y="213299"/>
            <a:ext cx="5135025" cy="64704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1376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矩形 13"/>
          <p:cNvSpPr/>
          <p:nvPr/>
        </p:nvSpPr>
        <p:spPr>
          <a:xfrm>
            <a:off x="1127667" y="4923332"/>
            <a:ext cx="721587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ing results of the homozygous edited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mbryo (#21)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ing gRNA-2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nger sequencing chromatographs of a wild-type (WT) embryo and the homozygous edited embryo are shown. </a:t>
            </a:r>
          </a:p>
        </p:txBody>
      </p:sp>
      <p:grpSp>
        <p:nvGrpSpPr>
          <p:cNvPr id="3" name="组合 2"/>
          <p:cNvGrpSpPr/>
          <p:nvPr/>
        </p:nvGrpSpPr>
        <p:grpSpPr>
          <a:xfrm>
            <a:off x="2027617" y="515382"/>
            <a:ext cx="5435447" cy="3316400"/>
            <a:chOff x="2027617" y="515382"/>
            <a:chExt cx="5435447" cy="3316400"/>
          </a:xfrm>
        </p:grpSpPr>
        <p:grpSp>
          <p:nvGrpSpPr>
            <p:cNvPr id="10" name="组合 9"/>
            <p:cNvGrpSpPr/>
            <p:nvPr/>
          </p:nvGrpSpPr>
          <p:grpSpPr>
            <a:xfrm>
              <a:off x="2027617" y="515382"/>
              <a:ext cx="5435447" cy="3316400"/>
              <a:chOff x="1644549" y="845843"/>
              <a:chExt cx="5435447" cy="3316400"/>
            </a:xfrm>
          </p:grpSpPr>
          <p:pic>
            <p:nvPicPr>
              <p:cNvPr id="4" name="图片 3"/>
              <p:cNvPicPr>
                <a:picLocks noChangeAspect="1"/>
              </p:cNvPicPr>
              <p:nvPr/>
            </p:nvPicPr>
            <p:blipFill rotWithShape="1">
              <a:blip r:embed="rId2"/>
              <a:srcRect l="22353"/>
              <a:stretch/>
            </p:blipFill>
            <p:spPr>
              <a:xfrm>
                <a:off x="4274287" y="845843"/>
                <a:ext cx="2499739" cy="2721600"/>
              </a:xfrm>
              <a:prstGeom prst="rect">
                <a:avLst/>
              </a:prstGeom>
            </p:spPr>
          </p:pic>
          <p:pic>
            <p:nvPicPr>
              <p:cNvPr id="7" name="图片 6"/>
              <p:cNvPicPr>
                <a:picLocks noChangeAspect="1"/>
              </p:cNvPicPr>
              <p:nvPr/>
            </p:nvPicPr>
            <p:blipFill rotWithShape="1">
              <a:blip r:embed="rId3"/>
              <a:srcRect l="23564"/>
              <a:stretch/>
            </p:blipFill>
            <p:spPr>
              <a:xfrm>
                <a:off x="1644549" y="846790"/>
                <a:ext cx="2479685" cy="2720653"/>
              </a:xfrm>
              <a:prstGeom prst="rect">
                <a:avLst/>
              </a:prstGeom>
            </p:spPr>
          </p:pic>
          <p:sp>
            <p:nvSpPr>
              <p:cNvPr id="8" name="文本框 7"/>
              <p:cNvSpPr txBox="1"/>
              <p:nvPr/>
            </p:nvSpPr>
            <p:spPr>
              <a:xfrm>
                <a:off x="2610824" y="3792911"/>
                <a:ext cx="65337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文本框 8"/>
              <p:cNvSpPr txBox="1"/>
              <p:nvPr/>
            </p:nvSpPr>
            <p:spPr>
              <a:xfrm>
                <a:off x="4230470" y="3792911"/>
                <a:ext cx="284952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mozygous edited embryo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2" name="等腰三角形 11"/>
            <p:cNvSpPr/>
            <p:nvPr/>
          </p:nvSpPr>
          <p:spPr>
            <a:xfrm>
              <a:off x="2765726" y="3239801"/>
              <a:ext cx="109057" cy="10800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endParaRPr lang="zh-CN" altLang="en-US">
                <a:solidFill>
                  <a:schemeClr val="tx1"/>
                </a:solidFill>
              </a:endParaRPr>
            </a:p>
          </p:txBody>
        </p:sp>
        <p:sp>
          <p:nvSpPr>
            <p:cNvPr id="15" name="等腰三角形 14"/>
            <p:cNvSpPr/>
            <p:nvPr/>
          </p:nvSpPr>
          <p:spPr>
            <a:xfrm>
              <a:off x="5423326" y="3279467"/>
              <a:ext cx="109057" cy="108000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endParaRPr lang="zh-CN" altLang="en-US">
                <a:solidFill>
                  <a:srgbClr val="FF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730534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2066193" y="6238045"/>
            <a:ext cx="496765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nger sequencing results of founder mice edited using gRNA-1 (A) and gRNA-2 (B).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5458" y="-12700"/>
            <a:ext cx="7200000" cy="3447667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5458" y="3301165"/>
            <a:ext cx="7200000" cy="310291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14300" y="1564567"/>
            <a:ext cx="1231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NA-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114300" y="4827568"/>
            <a:ext cx="1231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NA-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5"/>
          <p:cNvSpPr txBox="1"/>
          <p:nvPr/>
        </p:nvSpPr>
        <p:spPr>
          <a:xfrm>
            <a:off x="673100" y="180267"/>
            <a:ext cx="393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5"/>
          <p:cNvSpPr txBox="1"/>
          <p:nvPr/>
        </p:nvSpPr>
        <p:spPr>
          <a:xfrm>
            <a:off x="730250" y="3259020"/>
            <a:ext cx="393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25919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矩形 8"/>
          <p:cNvSpPr/>
          <p:nvPr/>
        </p:nvSpPr>
        <p:spPr>
          <a:xfrm>
            <a:off x="394790" y="4793281"/>
            <a:ext cx="4562245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nt spectra in founder mice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amplicons from gRNA-1 and gRNA-2 founder mice were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cloned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to the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EM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 vector and sequenced. The number of clones for each pattern is indicated.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N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rget sequence is underlined. PAM, green. Point mutation, red.</a:t>
            </a:r>
          </a:p>
        </p:txBody>
      </p:sp>
      <p:grpSp>
        <p:nvGrpSpPr>
          <p:cNvPr id="5" name="组合 4"/>
          <p:cNvGrpSpPr/>
          <p:nvPr/>
        </p:nvGrpSpPr>
        <p:grpSpPr>
          <a:xfrm>
            <a:off x="4957035" y="2122"/>
            <a:ext cx="3621600" cy="5560064"/>
            <a:chOff x="4957035" y="2122"/>
            <a:chExt cx="3621600" cy="5560064"/>
          </a:xfrm>
        </p:grpSpPr>
        <p:sp>
          <p:nvSpPr>
            <p:cNvPr id="11" name="文本框 10"/>
            <p:cNvSpPr txBox="1"/>
            <p:nvPr/>
          </p:nvSpPr>
          <p:spPr>
            <a:xfrm>
              <a:off x="6604051" y="2122"/>
              <a:ext cx="14676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NA-2</a:t>
              </a:r>
              <a:endParaRPr lang="zh-CN" altLang="en-US" dirty="0"/>
            </a:p>
          </p:txBody>
        </p:sp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957035" y="320714"/>
              <a:ext cx="3621600" cy="5241472"/>
            </a:xfrm>
            <a:prstGeom prst="rect">
              <a:avLst/>
            </a:prstGeom>
          </p:spPr>
        </p:pic>
      </p:grpSp>
      <p:grpSp>
        <p:nvGrpSpPr>
          <p:cNvPr id="4" name="组合 3"/>
          <p:cNvGrpSpPr/>
          <p:nvPr/>
        </p:nvGrpSpPr>
        <p:grpSpPr>
          <a:xfrm>
            <a:off x="487275" y="-28664"/>
            <a:ext cx="3687497" cy="4739990"/>
            <a:chOff x="487275" y="-28664"/>
            <a:chExt cx="3687497" cy="4739990"/>
          </a:xfrm>
        </p:grpSpPr>
        <p:sp>
          <p:nvSpPr>
            <p:cNvPr id="6" name="文本框 5"/>
            <p:cNvSpPr txBox="1"/>
            <p:nvPr/>
          </p:nvSpPr>
          <p:spPr>
            <a:xfrm>
              <a:off x="1923519" y="-28664"/>
              <a:ext cx="14676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NA-1</a:t>
              </a:r>
              <a:endParaRPr lang="zh-CN" altLang="en-US" dirty="0"/>
            </a:p>
          </p:txBody>
        </p:sp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87275" y="642467"/>
              <a:ext cx="3687497" cy="4068859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 rotWithShape="1">
            <a:blip r:embed="rId4"/>
            <a:srcRect r="14045" b="86375"/>
            <a:stretch/>
          </p:blipFill>
          <p:spPr>
            <a:xfrm>
              <a:off x="508057" y="340668"/>
              <a:ext cx="3204000" cy="14381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9749926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1174473" y="3677375"/>
            <a:ext cx="6726115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amination occurs outside the gRNA target site. </a:t>
            </a:r>
          </a:p>
          <a:p>
            <a:pPr algn="just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licon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P3 founder mouse from the gRNA-2 group were cloned into the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EM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 vector and verified by Sanger sequencing. 4 out of the 12 clones analyzed show obvious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amination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the target strand outside the gRNA-2 target site. gRNA-2 target sequence is underlined. PAM, green. Point mutation, red.</a:t>
            </a: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1330" y="1487754"/>
            <a:ext cx="7772400" cy="13840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35421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1377463" y="5119313"/>
            <a:ext cx="6509238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rmline transmission of the mutant allele. </a:t>
            </a:r>
          </a:p>
          <a:p>
            <a:pPr algn="just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licon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target region in F1 offspring from the P11 founder mouse were sequenced. Sanger sequencing chromatographs of the edited F1 pup is shown. Red arrowhead, the base edited by HF2-BE2.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63998" y="1240189"/>
            <a:ext cx="3819048" cy="3466667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2404549" y="947801"/>
            <a:ext cx="4078617" cy="292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70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TTGTGGGAACA</a:t>
            </a:r>
            <a:r>
              <a:rPr lang="zh-CN" altLang="en-US" sz="1270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AGAAATTCGAGAACTAACTG</a:t>
            </a:r>
            <a:r>
              <a:rPr lang="en-US" altLang="zh-CN" sz="1270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GGG</a:t>
            </a:r>
            <a:endParaRPr lang="zh-CN" altLang="en-US" sz="1270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8" name="等腰三角形 7"/>
          <p:cNvSpPr/>
          <p:nvPr/>
        </p:nvSpPr>
        <p:spPr>
          <a:xfrm>
            <a:off x="2894606" y="4717869"/>
            <a:ext cx="109057" cy="108000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9" name="等腰三角形 8"/>
          <p:cNvSpPr/>
          <p:nvPr/>
        </p:nvSpPr>
        <p:spPr>
          <a:xfrm>
            <a:off x="3026167" y="4717869"/>
            <a:ext cx="109057" cy="108000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0" name="等腰三角形 9"/>
          <p:cNvSpPr/>
          <p:nvPr/>
        </p:nvSpPr>
        <p:spPr>
          <a:xfrm>
            <a:off x="3166558" y="4717869"/>
            <a:ext cx="109057" cy="108000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653577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2</TotalTime>
  <Words>290</Words>
  <Application>Microsoft Office PowerPoint</Application>
  <PresentationFormat>全屏显示(4:3)</PresentationFormat>
  <Paragraphs>17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4" baseType="lpstr">
      <vt:lpstr>等线</vt:lpstr>
      <vt:lpstr>等线 Light</vt:lpstr>
      <vt:lpstr>黑体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uping Liang</dc:creator>
  <cp:lastModifiedBy>Administrator</cp:lastModifiedBy>
  <cp:revision>84</cp:revision>
  <dcterms:created xsi:type="dcterms:W3CDTF">2017-03-08T17:24:29Z</dcterms:created>
  <dcterms:modified xsi:type="dcterms:W3CDTF">2017-04-24T05:41:57Z</dcterms:modified>
</cp:coreProperties>
</file>